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49" autoAdjust="0"/>
    <p:restoredTop sz="96797"/>
  </p:normalViewPr>
  <p:slideViewPr>
    <p:cSldViewPr snapToGrid="0" snapToObjects="1">
      <p:cViewPr>
        <p:scale>
          <a:sx n="150" d="100"/>
          <a:sy n="150" d="100"/>
        </p:scale>
        <p:origin x="2200" y="-2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iscobarrolosada/OneDrive/Manuscripts%20One%20drive/Paper%20CRISPR_NB/Analisis_geles_MJ_Lola_Susana/Nueva%20gra&#769;fica%20V520%20y%20dema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iscobarrolosada/OneDrive/Manuscripts%20One%20drive/Paper%20CRISPR_NB/Analisis_geles_MJ_Lola_Susana/Nueva%20gra&#769;fica%20V520%20y%20dema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iscobarrolosada/OneDrive/Manuscripts%20One%20drive/Paper%20CRISPR_NB/Analisis_geles_MJ_Lola_Susana/Nueva%20gra&#769;fica%20V520%20y%20dema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iscobarrolosada/OneDrive/Manuscripts%20One%20drive/Paper%20CRISPR_NB/Analisis_geles_MJ_Lola_Susana/Nueva%20gra&#769;fica%20V520%20y%20dema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iscobarrolosada/OneDrive/Manuscripts%20One%20drive/Paper%20CRISPR_NB/Analisis_geles_MJ_Lola_Susana/Nueva%20gra&#769;fica%20V520%20y%20dema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4972563730432"/>
          <c:y val="0.0501930501930502"/>
          <c:w val="0.542175700831301"/>
          <c:h val="0.709967568019089"/>
        </c:manualLayout>
      </c:layout>
      <c:lineChart>
        <c:grouping val="standard"/>
        <c:varyColors val="0"/>
        <c:ser>
          <c:idx val="0"/>
          <c:order val="0"/>
          <c:tx>
            <c:strRef>
              <c:f>DPedro!$D$8</c:f>
              <c:strCache>
                <c:ptCount val="1"/>
                <c:pt idx="0">
                  <c:v>DP</c:v>
                </c:pt>
              </c:strCache>
            </c:strRef>
          </c:tx>
          <c:spPr>
            <a:ln>
              <a:noFill/>
            </a:ln>
          </c:spPr>
          <c:marker>
            <c:symbol val="squar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DPedro!$L$22:$M$22</c:f>
                <c:numCache>
                  <c:formatCode>General</c:formatCode>
                  <c:ptCount val="2"/>
                  <c:pt idx="0">
                    <c:v>1.090739616950013</c:v>
                  </c:pt>
                  <c:pt idx="1">
                    <c:v>4.983263487455036</c:v>
                  </c:pt>
                </c:numCache>
              </c:numRef>
            </c:plus>
            <c:minus>
              <c:numRef>
                <c:f>DPedro!$L$22:$M$22</c:f>
                <c:numCache>
                  <c:formatCode>General</c:formatCode>
                  <c:ptCount val="2"/>
                  <c:pt idx="0">
                    <c:v>1.090739616950013</c:v>
                  </c:pt>
                  <c:pt idx="1">
                    <c:v>4.983263487455036</c:v>
                  </c:pt>
                </c:numCache>
              </c:numRef>
            </c:minus>
            <c:spPr>
              <a:effectLst>
                <a:outerShdw blurRad="50800" dist="38100" dir="21540000" algn="tl" rotWithShape="0">
                  <a:prstClr val="black"/>
                </a:outerShdw>
              </a:effectLst>
            </c:spPr>
          </c:errBars>
          <c:cat>
            <c:strRef>
              <c:f>DPedro!$L$1:$M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DPedro!$L$20:$M$20</c:f>
              <c:numCache>
                <c:formatCode>0.00</c:formatCode>
                <c:ptCount val="2"/>
                <c:pt idx="0">
                  <c:v>6.391512553895607</c:v>
                </c:pt>
                <c:pt idx="1">
                  <c:v>29.6577111851920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DPedro!$E$2</c:f>
              <c:strCache>
                <c:ptCount val="1"/>
                <c:pt idx="0">
                  <c:v>V520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</c:marker>
          <c:cat>
            <c:strRef>
              <c:f>DPedro!$L$1:$M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DPedro!$L$2:$M$2</c:f>
              <c:numCache>
                <c:formatCode>0.00</c:formatCode>
                <c:ptCount val="2"/>
                <c:pt idx="0">
                  <c:v>5.031883398975231</c:v>
                </c:pt>
                <c:pt idx="1">
                  <c:v>13.8975883355223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DPedro!$F$4</c:f>
              <c:strCache>
                <c:ptCount val="1"/>
                <c:pt idx="0">
                  <c:v>V775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DPedro!$L$1:$M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DPedro!$L$4:$M$4</c:f>
              <c:numCache>
                <c:formatCode>0.00</c:formatCode>
                <c:ptCount val="2"/>
                <c:pt idx="0">
                  <c:v>25.83145744889262</c:v>
                </c:pt>
                <c:pt idx="1">
                  <c:v>35.96315083356327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DPedro!$F$5</c:f>
              <c:strCache>
                <c:ptCount val="1"/>
                <c:pt idx="0">
                  <c:v>V778</c:v>
                </c:pt>
              </c:strCache>
            </c:strRef>
          </c:tx>
          <c:spPr>
            <a:ln w="28575">
              <a:noFill/>
            </a:ln>
          </c:spPr>
          <c:marker>
            <c:symbol val="star"/>
            <c:size val="7"/>
          </c:marker>
          <c:cat>
            <c:strRef>
              <c:f>DPedro!$L$1:$M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DPedro!$L$5:$M$5</c:f>
              <c:numCache>
                <c:formatCode>0.00</c:formatCode>
                <c:ptCount val="2"/>
                <c:pt idx="0">
                  <c:v>31.54670744630078</c:v>
                </c:pt>
                <c:pt idx="1">
                  <c:v>31.08046192575242</c:v>
                </c:pt>
              </c:numCache>
            </c:numRef>
          </c:val>
          <c:smooth val="0"/>
        </c:ser>
        <c:ser>
          <c:idx val="3"/>
          <c:order val="4"/>
          <c:tx>
            <c:strRef>
              <c:f>DPedro!$F$6</c:f>
              <c:strCache>
                <c:ptCount val="1"/>
                <c:pt idx="0">
                  <c:v>V780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cat>
            <c:strRef>
              <c:f>DPedro!$L$1:$M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DPedro!$L$6:$M$6</c:f>
              <c:numCache>
                <c:formatCode>0.00</c:formatCode>
                <c:ptCount val="2"/>
                <c:pt idx="0">
                  <c:v>38.85838410214409</c:v>
                </c:pt>
                <c:pt idx="1">
                  <c:v>30.6938919453944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19556416"/>
        <c:axId val="-1525465360"/>
      </c:lineChart>
      <c:catAx>
        <c:axId val="-16195564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525465360"/>
        <c:crosses val="autoZero"/>
        <c:auto val="1"/>
        <c:lblAlgn val="ctr"/>
        <c:lblOffset val="100"/>
        <c:noMultiLvlLbl val="0"/>
      </c:catAx>
      <c:valAx>
        <c:axId val="-15254653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s-ES" sz="1000"/>
                  <a:t>Protein content (µg/mg flour)</a:t>
                </a:r>
              </a:p>
            </c:rich>
          </c:tx>
          <c:layout>
            <c:manualLayout>
              <c:xMode val="edge"/>
              <c:yMode val="edge"/>
              <c:x val="0.0214970746957807"/>
              <c:y val="0.044427364892471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6195564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98364994725353"/>
          <c:y val="0.176892758370847"/>
          <c:w val="0.164537439179407"/>
          <c:h val="0.492086306113592"/>
        </c:manualLayout>
      </c:layout>
      <c:overlay val="0"/>
      <c:txPr>
        <a:bodyPr/>
        <a:lstStyle/>
        <a:p>
          <a:pPr>
            <a:defRPr sz="1000"/>
          </a:pPr>
          <a:endParaRPr lang="es-ES_tradnl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633711358352"/>
          <c:y val="0.100971455716987"/>
          <c:w val="0.773102635100411"/>
          <c:h val="0.709552093737802"/>
        </c:manualLayout>
      </c:layout>
      <c:lineChart>
        <c:grouping val="standard"/>
        <c:varyColors val="0"/>
        <c:ser>
          <c:idx val="0"/>
          <c:order val="0"/>
          <c:tx>
            <c:strRef>
              <c:f>DPedro!$D$8</c:f>
              <c:strCache>
                <c:ptCount val="1"/>
                <c:pt idx="0">
                  <c:v>DP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DPedro!$O$22:$Q$22</c:f>
                <c:numCache>
                  <c:formatCode>General</c:formatCode>
                  <c:ptCount val="3"/>
                  <c:pt idx="0">
                    <c:v>10.53812698375513</c:v>
                  </c:pt>
                  <c:pt idx="1">
                    <c:v>5.984665298293094</c:v>
                  </c:pt>
                  <c:pt idx="2">
                    <c:v>14.21536052004934</c:v>
                  </c:pt>
                </c:numCache>
              </c:numRef>
            </c:plus>
            <c:minus>
              <c:numRef>
                <c:f>DPedro!$O$22:$Q$22</c:f>
                <c:numCache>
                  <c:formatCode>General</c:formatCode>
                  <c:ptCount val="3"/>
                  <c:pt idx="0">
                    <c:v>10.53812698375513</c:v>
                  </c:pt>
                  <c:pt idx="1">
                    <c:v>5.984665298293094</c:v>
                  </c:pt>
                  <c:pt idx="2">
                    <c:v>14.21536052004934</c:v>
                  </c:pt>
                </c:numCache>
              </c:numRef>
            </c:minus>
            <c:spPr>
              <a:effectLst>
                <a:outerShdw blurRad="50800" dist="38100" dir="21540000" algn="tl" rotWithShape="0">
                  <a:prstClr val="black"/>
                </a:outerShdw>
              </a:effectLst>
            </c:spPr>
          </c:errBars>
          <c:cat>
            <c:strRef>
              <c:f>DPedro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DPedro!$O$20:$Q$20</c:f>
              <c:numCache>
                <c:formatCode>0.00</c:formatCode>
                <c:ptCount val="3"/>
                <c:pt idx="0">
                  <c:v>75.9871114859876</c:v>
                </c:pt>
                <c:pt idx="1">
                  <c:v>36.04922373908769</c:v>
                </c:pt>
                <c:pt idx="2">
                  <c:v>112.036335225075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DPedro!$E$2</c:f>
              <c:strCache>
                <c:ptCount val="1"/>
                <c:pt idx="0">
                  <c:v>V520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</c:marker>
          <c:cat>
            <c:strRef>
              <c:f>DPedro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DPedro!$O$2:$Q$2</c:f>
              <c:numCache>
                <c:formatCode>0.00</c:formatCode>
                <c:ptCount val="3"/>
                <c:pt idx="0">
                  <c:v>47.84160595202064</c:v>
                </c:pt>
                <c:pt idx="1">
                  <c:v>18.92947173449754</c:v>
                </c:pt>
                <c:pt idx="2">
                  <c:v>66.7710776865181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DPedro!$F$4</c:f>
              <c:strCache>
                <c:ptCount val="1"/>
                <c:pt idx="0">
                  <c:v>V775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DPedro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DPedro!$O$4:$Q$4</c:f>
              <c:numCache>
                <c:formatCode>0.00</c:formatCode>
                <c:ptCount val="3"/>
                <c:pt idx="0">
                  <c:v>70.22945969450904</c:v>
                </c:pt>
                <c:pt idx="1">
                  <c:v>61.7946082824559</c:v>
                </c:pt>
                <c:pt idx="2">
                  <c:v>132.024067976965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DPedro!$F$5</c:f>
              <c:strCache>
                <c:ptCount val="1"/>
                <c:pt idx="0">
                  <c:v>V778</c:v>
                </c:pt>
              </c:strCache>
            </c:strRef>
          </c:tx>
          <c:spPr>
            <a:ln w="28575">
              <a:noFill/>
            </a:ln>
          </c:spPr>
          <c:marker>
            <c:symbol val="star"/>
            <c:size val="7"/>
          </c:marker>
          <c:cat>
            <c:strRef>
              <c:f>DPedro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DPedro!$O$5:$Q$5</c:f>
              <c:numCache>
                <c:formatCode>0.00</c:formatCode>
                <c:ptCount val="3"/>
                <c:pt idx="0">
                  <c:v>59.92685593463473</c:v>
                </c:pt>
                <c:pt idx="1">
                  <c:v>62.6271693720532</c:v>
                </c:pt>
                <c:pt idx="2">
                  <c:v>122.5540253066879</c:v>
                </c:pt>
              </c:numCache>
            </c:numRef>
          </c:val>
          <c:smooth val="0"/>
        </c:ser>
        <c:ser>
          <c:idx val="3"/>
          <c:order val="4"/>
          <c:tx>
            <c:strRef>
              <c:f>DPedro!$F$6</c:f>
              <c:strCache>
                <c:ptCount val="1"/>
                <c:pt idx="0">
                  <c:v>V780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cat>
            <c:strRef>
              <c:f>DPedro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DPedro!$O$6:$Q$6</c:f>
              <c:numCache>
                <c:formatCode>0.00</c:formatCode>
                <c:ptCount val="3"/>
                <c:pt idx="0">
                  <c:v>48.1129003698521</c:v>
                </c:pt>
                <c:pt idx="1">
                  <c:v>69.55227604753851</c:v>
                </c:pt>
                <c:pt idx="2">
                  <c:v>117.665176417390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525049440"/>
        <c:axId val="-1525045376"/>
      </c:lineChart>
      <c:catAx>
        <c:axId val="-1525049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/>
            </a:pPr>
            <a:endParaRPr lang="es-ES_tradnl"/>
          </a:p>
        </c:txPr>
        <c:crossAx val="-1525045376"/>
        <c:crosses val="autoZero"/>
        <c:auto val="1"/>
        <c:lblAlgn val="ctr"/>
        <c:lblOffset val="100"/>
        <c:noMultiLvlLbl val="0"/>
      </c:catAx>
      <c:valAx>
        <c:axId val="-15250453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s-ES" sz="1000"/>
                  <a:t>Protein</a:t>
                </a:r>
                <a:r>
                  <a:rPr lang="es-ES" sz="1000" dirty="0"/>
                  <a:t> </a:t>
                </a:r>
                <a:r>
                  <a:rPr lang="es-ES" sz="1000" dirty="0" err="1"/>
                  <a:t>content</a:t>
                </a:r>
                <a:r>
                  <a:rPr lang="es-ES" sz="1000" dirty="0"/>
                  <a:t> (µg/mg </a:t>
                </a:r>
                <a:r>
                  <a:rPr lang="es-ES" sz="1000" dirty="0" err="1"/>
                  <a:t>flour</a:t>
                </a:r>
                <a:r>
                  <a:rPr lang="es-ES" sz="1000" dirty="0"/>
                  <a:t>)</a:t>
                </a:r>
              </a:p>
            </c:rich>
          </c:tx>
          <c:layout>
            <c:manualLayout>
              <c:xMode val="edge"/>
              <c:yMode val="edge"/>
              <c:x val="0.0224439837046075"/>
              <c:y val="0.08482303692296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52504944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BW208'!$E$5</c:f>
              <c:strCache>
                <c:ptCount val="1"/>
                <c:pt idx="0">
                  <c:v>BW208</c:v>
                </c:pt>
              </c:strCache>
            </c:strRef>
          </c:tx>
          <c:spPr>
            <a:ln>
              <a:noFill/>
            </a:ln>
          </c:spPr>
          <c:marker>
            <c:symbol val="squar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'BW208'!$G$16:$I$16</c:f>
                <c:numCache>
                  <c:formatCode>General</c:formatCode>
                  <c:ptCount val="3"/>
                  <c:pt idx="0">
                    <c:v>1.655046974465437</c:v>
                  </c:pt>
                  <c:pt idx="1">
                    <c:v>8.00226572784355</c:v>
                  </c:pt>
                  <c:pt idx="2">
                    <c:v>4.008962841673593</c:v>
                  </c:pt>
                </c:numCache>
              </c:numRef>
            </c:plus>
            <c:minus>
              <c:numRef>
                <c:f>'BW208'!$G$16:$I$16</c:f>
                <c:numCache>
                  <c:formatCode>General</c:formatCode>
                  <c:ptCount val="3"/>
                  <c:pt idx="0">
                    <c:v>1.655046974465437</c:v>
                  </c:pt>
                  <c:pt idx="1">
                    <c:v>8.00226572784355</c:v>
                  </c:pt>
                  <c:pt idx="2">
                    <c:v>4.008962841673593</c:v>
                  </c:pt>
                </c:numCache>
              </c:numRef>
            </c:minus>
            <c:spPr>
              <a:effectLst>
                <a:outerShdw blurRad="50800" dist="50800" dir="21540000" algn="ctr" rotWithShape="0">
                  <a:srgbClr val="000000"/>
                </a:outerShdw>
              </a:effectLst>
            </c:spPr>
          </c:errBars>
          <c:cat>
            <c:strRef>
              <c:f>'BW208'!$G$1:$I$1</c:f>
              <c:strCache>
                <c:ptCount val="3"/>
                <c:pt idx="0">
                  <c:v>Omega</c:v>
                </c:pt>
                <c:pt idx="1">
                  <c:v>Alpha</c:v>
                </c:pt>
                <c:pt idx="2">
                  <c:v>Gamma</c:v>
                </c:pt>
              </c:strCache>
            </c:strRef>
          </c:cat>
          <c:val>
            <c:numRef>
              <c:f>'BW208'!$G$14:$I$14</c:f>
              <c:numCache>
                <c:formatCode>0.00</c:formatCode>
                <c:ptCount val="3"/>
                <c:pt idx="0">
                  <c:v>14.34351494436574</c:v>
                </c:pt>
                <c:pt idx="1">
                  <c:v>35.22532556239822</c:v>
                </c:pt>
                <c:pt idx="2">
                  <c:v>37.677863389772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W208'!$F$2</c:f>
              <c:strCache>
                <c:ptCount val="1"/>
                <c:pt idx="0">
                  <c:v>V705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</c:marker>
          <c:cat>
            <c:strRef>
              <c:f>'BW208'!$G$1:$I$1</c:f>
              <c:strCache>
                <c:ptCount val="3"/>
                <c:pt idx="0">
                  <c:v>Omega</c:v>
                </c:pt>
                <c:pt idx="1">
                  <c:v>Alpha</c:v>
                </c:pt>
                <c:pt idx="2">
                  <c:v>Gamma</c:v>
                </c:pt>
              </c:strCache>
            </c:strRef>
          </c:cat>
          <c:val>
            <c:numRef>
              <c:f>'BW208'!$G$2:$I$2</c:f>
              <c:numCache>
                <c:formatCode>0.00</c:formatCode>
                <c:ptCount val="3"/>
                <c:pt idx="0">
                  <c:v>13.070739564033</c:v>
                </c:pt>
                <c:pt idx="1">
                  <c:v>29.68225506387431</c:v>
                </c:pt>
                <c:pt idx="2">
                  <c:v>23.772873755993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W208'!$F$3</c:f>
              <c:strCache>
                <c:ptCount val="1"/>
                <c:pt idx="0">
                  <c:v>V739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'BW208'!$G$1:$I$1</c:f>
              <c:strCache>
                <c:ptCount val="3"/>
                <c:pt idx="0">
                  <c:v>Omega</c:v>
                </c:pt>
                <c:pt idx="1">
                  <c:v>Alpha</c:v>
                </c:pt>
                <c:pt idx="2">
                  <c:v>Gamma</c:v>
                </c:pt>
              </c:strCache>
            </c:strRef>
          </c:cat>
          <c:val>
            <c:numRef>
              <c:f>'BW208'!$G$3:$I$3</c:f>
              <c:numCache>
                <c:formatCode>0.00</c:formatCode>
                <c:ptCount val="3"/>
                <c:pt idx="0">
                  <c:v>7.92017479507443</c:v>
                </c:pt>
                <c:pt idx="1">
                  <c:v>21.5707825106111</c:v>
                </c:pt>
                <c:pt idx="2">
                  <c:v>15.1035066359101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BW208'!$F$4</c:f>
              <c:strCache>
                <c:ptCount val="1"/>
                <c:pt idx="0">
                  <c:v>V740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cat>
            <c:strRef>
              <c:f>'BW208'!$G$1:$I$1</c:f>
              <c:strCache>
                <c:ptCount val="3"/>
                <c:pt idx="0">
                  <c:v>Omega</c:v>
                </c:pt>
                <c:pt idx="1">
                  <c:v>Alpha</c:v>
                </c:pt>
                <c:pt idx="2">
                  <c:v>Gamma</c:v>
                </c:pt>
              </c:strCache>
            </c:strRef>
          </c:cat>
          <c:val>
            <c:numRef>
              <c:f>'BW208'!$G$4:$I$4</c:f>
              <c:numCache>
                <c:formatCode>0.00</c:formatCode>
                <c:ptCount val="3"/>
                <c:pt idx="0">
                  <c:v>9.195175045120341</c:v>
                </c:pt>
                <c:pt idx="1">
                  <c:v>23.82769299415809</c:v>
                </c:pt>
                <c:pt idx="2">
                  <c:v>18.8710295711535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524741856"/>
        <c:axId val="-1525616160"/>
      </c:lineChart>
      <c:catAx>
        <c:axId val="-15247418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525616160"/>
        <c:crosses val="autoZero"/>
        <c:auto val="1"/>
        <c:lblAlgn val="ctr"/>
        <c:lblOffset val="100"/>
        <c:noMultiLvlLbl val="0"/>
      </c:catAx>
      <c:valAx>
        <c:axId val="-15256161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s-ES" sz="1000"/>
                  <a:t>Protein content (µg/mg flour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524741856"/>
        <c:crosses val="autoZero"/>
        <c:crossBetween val="between"/>
        <c:majorUnit val="10.0"/>
      </c:valAx>
    </c:plotArea>
    <c:legend>
      <c:legendPos val="r"/>
      <c:layout/>
      <c:overlay val="0"/>
      <c:txPr>
        <a:bodyPr/>
        <a:lstStyle/>
        <a:p>
          <a:pPr>
            <a:defRPr sz="1000"/>
          </a:pPr>
          <a:endParaRPr lang="es-ES_tradnl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BW208'!$E$5</c:f>
              <c:strCache>
                <c:ptCount val="1"/>
                <c:pt idx="0">
                  <c:v>BW208</c:v>
                </c:pt>
              </c:strCache>
            </c:strRef>
          </c:tx>
          <c:spPr>
            <a:ln>
              <a:noFill/>
            </a:ln>
          </c:spPr>
          <c:marker>
            <c:symbol val="squar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'BW208'!$M$16:$N$16</c:f>
                <c:numCache>
                  <c:formatCode>General</c:formatCode>
                  <c:ptCount val="2"/>
                  <c:pt idx="0">
                    <c:v>1.341898223640764</c:v>
                  </c:pt>
                  <c:pt idx="1">
                    <c:v>2.593220607348892</c:v>
                  </c:pt>
                </c:numCache>
              </c:numRef>
            </c:plus>
            <c:minus>
              <c:numRef>
                <c:f>'BW208'!$M$16:$N$16</c:f>
                <c:numCache>
                  <c:formatCode>General</c:formatCode>
                  <c:ptCount val="2"/>
                  <c:pt idx="0">
                    <c:v>1.341898223640764</c:v>
                  </c:pt>
                  <c:pt idx="1">
                    <c:v>2.593220607348892</c:v>
                  </c:pt>
                </c:numCache>
              </c:numRef>
            </c:minus>
            <c:spPr>
              <a:effectLst>
                <a:outerShdw blurRad="50800" dist="50800" dir="21540000" algn="ctr" rotWithShape="0">
                  <a:srgbClr val="000000"/>
                </a:outerShdw>
              </a:effectLst>
            </c:spPr>
          </c:errBars>
          <c:cat>
            <c:strRef>
              <c:f>'BW208'!$M$1:$N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'BW208'!$M$14:$N$14</c:f>
              <c:numCache>
                <c:formatCode>0.00</c:formatCode>
                <c:ptCount val="2"/>
                <c:pt idx="0">
                  <c:v>10.0531051050521</c:v>
                </c:pt>
                <c:pt idx="1">
                  <c:v>22.5946440734784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W208'!$F$2</c:f>
              <c:strCache>
                <c:ptCount val="1"/>
                <c:pt idx="0">
                  <c:v>V705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</c:marker>
          <c:cat>
            <c:strRef>
              <c:f>'BW208'!$M$1:$N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'BW208'!$M$2:$N$2</c:f>
              <c:numCache>
                <c:formatCode>0.00</c:formatCode>
                <c:ptCount val="2"/>
                <c:pt idx="0">
                  <c:v>9.392625129848406</c:v>
                </c:pt>
                <c:pt idx="1">
                  <c:v>17.5851969523050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W208'!$F$3</c:f>
              <c:strCache>
                <c:ptCount val="1"/>
                <c:pt idx="0">
                  <c:v>V739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'BW208'!$M$1:$N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'BW208'!$M$3:$N$3</c:f>
              <c:numCache>
                <c:formatCode>0.00</c:formatCode>
                <c:ptCount val="2"/>
                <c:pt idx="0">
                  <c:v>14.79136416657307</c:v>
                </c:pt>
                <c:pt idx="1">
                  <c:v>18.5701122010231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BW208'!$F$4</c:f>
              <c:strCache>
                <c:ptCount val="1"/>
                <c:pt idx="0">
                  <c:v>V740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cat>
            <c:strRef>
              <c:f>'BW208'!$M$1:$N$1</c:f>
              <c:strCache>
                <c:ptCount val="2"/>
                <c:pt idx="0">
                  <c:v>HMW</c:v>
                </c:pt>
                <c:pt idx="1">
                  <c:v>LMW</c:v>
                </c:pt>
              </c:strCache>
            </c:strRef>
          </c:cat>
          <c:val>
            <c:numRef>
              <c:f>'BW208'!$M$4:$N$4</c:f>
              <c:numCache>
                <c:formatCode>0.00</c:formatCode>
                <c:ptCount val="2"/>
                <c:pt idx="0">
                  <c:v>18.28338821166437</c:v>
                </c:pt>
                <c:pt idx="1">
                  <c:v>25.2792564369602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19043264"/>
        <c:axId val="-1524699680"/>
      </c:lineChart>
      <c:catAx>
        <c:axId val="-1619043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524699680"/>
        <c:crosses val="autoZero"/>
        <c:auto val="1"/>
        <c:lblAlgn val="ctr"/>
        <c:lblOffset val="100"/>
        <c:noMultiLvlLbl val="0"/>
      </c:catAx>
      <c:valAx>
        <c:axId val="-1524699680"/>
        <c:scaling>
          <c:orientation val="minMax"/>
          <c:max val="3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s-ES" sz="1000"/>
                  <a:t>Protein content (µg/mg flour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619043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1943347208555"/>
          <c:y val="0.294043190262124"/>
          <c:w val="0.189825658842027"/>
          <c:h val="0.411913619475751"/>
        </c:manualLayout>
      </c:layout>
      <c:overlay val="0"/>
      <c:txPr>
        <a:bodyPr/>
        <a:lstStyle/>
        <a:p>
          <a:pPr>
            <a:defRPr sz="1000"/>
          </a:pPr>
          <a:endParaRPr lang="es-ES_tradnl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BW208'!$E$5</c:f>
              <c:strCache>
                <c:ptCount val="1"/>
                <c:pt idx="0">
                  <c:v>BW208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'BW208'!$O$16:$Q$16</c:f>
                <c:numCache>
                  <c:formatCode>General</c:formatCode>
                  <c:ptCount val="3"/>
                  <c:pt idx="0">
                    <c:v>10.3036399454325</c:v>
                  </c:pt>
                  <c:pt idx="1">
                    <c:v>3.571294010747925</c:v>
                  </c:pt>
                  <c:pt idx="2">
                    <c:v>12.16351658102113</c:v>
                  </c:pt>
                </c:numCache>
              </c:numRef>
            </c:plus>
            <c:minus>
              <c:numRef>
                <c:f>'BW208'!$O$16:$Q$16</c:f>
                <c:numCache>
                  <c:formatCode>General</c:formatCode>
                  <c:ptCount val="3"/>
                  <c:pt idx="0">
                    <c:v>10.3036399454325</c:v>
                  </c:pt>
                  <c:pt idx="1">
                    <c:v>3.571294010747925</c:v>
                  </c:pt>
                  <c:pt idx="2">
                    <c:v>12.16351658102113</c:v>
                  </c:pt>
                </c:numCache>
              </c:numRef>
            </c:minus>
            <c:spPr>
              <a:effectLst>
                <a:outerShdw blurRad="50800" dist="50800" dir="21540000" algn="ctr" rotWithShape="0">
                  <a:srgbClr val="000000"/>
                </a:outerShdw>
              </a:effectLst>
            </c:spPr>
          </c:errBars>
          <c:cat>
            <c:strRef>
              <c:f>'BW208'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'BW208'!$O$14:$Q$14</c:f>
              <c:numCache>
                <c:formatCode>0.00</c:formatCode>
                <c:ptCount val="3"/>
                <c:pt idx="0">
                  <c:v>87.24670389653683</c:v>
                </c:pt>
                <c:pt idx="1">
                  <c:v>32.64774917853055</c:v>
                </c:pt>
                <c:pt idx="2">
                  <c:v>119.894453075067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W208'!$F$2</c:f>
              <c:strCache>
                <c:ptCount val="1"/>
                <c:pt idx="0">
                  <c:v>V705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</c:marker>
          <c:cat>
            <c:strRef>
              <c:f>'BW208'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'BW208'!$O$2:$Q$2</c:f>
              <c:numCache>
                <c:formatCode>0.00</c:formatCode>
                <c:ptCount val="3"/>
                <c:pt idx="0">
                  <c:v>66.52586838390036</c:v>
                </c:pt>
                <c:pt idx="1">
                  <c:v>26.9778220821535</c:v>
                </c:pt>
                <c:pt idx="2">
                  <c:v>93.5036904660539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W208'!$F$3</c:f>
              <c:strCache>
                <c:ptCount val="1"/>
                <c:pt idx="0">
                  <c:v>V739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'BW208'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'BW208'!$O$3:$Q$3</c:f>
              <c:numCache>
                <c:formatCode>0.00</c:formatCode>
                <c:ptCount val="3"/>
                <c:pt idx="0">
                  <c:v>44.59446394159565</c:v>
                </c:pt>
                <c:pt idx="1">
                  <c:v>33.36147636759624</c:v>
                </c:pt>
                <c:pt idx="2">
                  <c:v>77.9559403091918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BW208'!$F$4</c:f>
              <c:strCache>
                <c:ptCount val="1"/>
                <c:pt idx="0">
                  <c:v>V740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cat>
            <c:strRef>
              <c:f>'BW208'!$O$1:$Q$1</c:f>
              <c:strCache>
                <c:ptCount val="3"/>
                <c:pt idx="0">
                  <c:v>Total Gliadins</c:v>
                </c:pt>
                <c:pt idx="1">
                  <c:v>Total Glutenins</c:v>
                </c:pt>
                <c:pt idx="2">
                  <c:v>Prolamins</c:v>
                </c:pt>
              </c:strCache>
            </c:strRef>
          </c:cat>
          <c:val>
            <c:numRef>
              <c:f>'BW208'!$O$4:$Q$4</c:f>
              <c:numCache>
                <c:formatCode>0.00</c:formatCode>
                <c:ptCount val="3"/>
                <c:pt idx="0">
                  <c:v>51.893897610432</c:v>
                </c:pt>
                <c:pt idx="1">
                  <c:v>43.5626446486246</c:v>
                </c:pt>
                <c:pt idx="2">
                  <c:v>95.4565422590565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19236352"/>
        <c:axId val="-1619514176"/>
      </c:lineChart>
      <c:catAx>
        <c:axId val="-16192363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619514176"/>
        <c:crosses val="autoZero"/>
        <c:auto val="1"/>
        <c:lblAlgn val="ctr"/>
        <c:lblOffset val="100"/>
        <c:noMultiLvlLbl val="0"/>
      </c:catAx>
      <c:valAx>
        <c:axId val="-1619514176"/>
        <c:scaling>
          <c:orientation val="minMax"/>
          <c:max val="15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s-ES" sz="1000"/>
                  <a:t>Protein content (µg/mg flour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s-ES_tradnl"/>
          </a:p>
        </c:txPr>
        <c:crossAx val="-16192363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932EA1-39D4-3742-A540-079CC386F82A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66C691-35DA-3642-9A5B-85D3C916736C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6959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49396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19444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282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10095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97274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39774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15732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8406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27803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0737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58412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38FA3-48D2-F748-9689-71E4A88CA086}" type="datetimeFigureOut">
              <a:rPr lang="es-ES_tradnl" smtClean="0"/>
              <a:t>1/8/17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8A40E-FED5-C24F-905F-F5706C771210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82877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chart" Target="../charts/chart1.xml"/><Relationship Id="rId5" Type="http://schemas.openxmlformats.org/officeDocument/2006/relationships/chart" Target="../charts/chart2.xml"/><Relationship Id="rId6" Type="http://schemas.openxmlformats.org/officeDocument/2006/relationships/chart" Target="../charts/chart3.xml"/><Relationship Id="rId7" Type="http://schemas.openxmlformats.org/officeDocument/2006/relationships/chart" Target="../charts/chart4.xml"/><Relationship Id="rId8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Agrupar 35"/>
          <p:cNvGrpSpPr/>
          <p:nvPr/>
        </p:nvGrpSpPr>
        <p:grpSpPr>
          <a:xfrm>
            <a:off x="4321149" y="2463529"/>
            <a:ext cx="1514367" cy="3065732"/>
            <a:chOff x="4706760" y="3274621"/>
            <a:chExt cx="1224532" cy="2819313"/>
          </a:xfrm>
        </p:grpSpPr>
        <p:grpSp>
          <p:nvGrpSpPr>
            <p:cNvPr id="23" name="Agrupar 22"/>
            <p:cNvGrpSpPr/>
            <p:nvPr/>
          </p:nvGrpSpPr>
          <p:grpSpPr>
            <a:xfrm>
              <a:off x="4991432" y="3274621"/>
              <a:ext cx="939860" cy="2819313"/>
              <a:chOff x="4157700" y="3284434"/>
              <a:chExt cx="839445" cy="2819313"/>
            </a:xfrm>
          </p:grpSpPr>
          <p:pic>
            <p:nvPicPr>
              <p:cNvPr id="16" name="Picture 2" descr="C:\Users\MJGIMENEZ\Desktop\_DSC0192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771" t="9640" r="29005"/>
              <a:stretch/>
            </p:blipFill>
            <p:spPr bwMode="auto">
              <a:xfrm flipH="1">
                <a:off x="4157700" y="3907747"/>
                <a:ext cx="839445" cy="2196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7" name="CuadroTexto 16"/>
              <p:cNvSpPr txBox="1"/>
              <p:nvPr/>
            </p:nvSpPr>
            <p:spPr>
              <a:xfrm rot="16200000">
                <a:off x="4285303" y="3641318"/>
                <a:ext cx="417481" cy="1778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smtClean="0"/>
                  <a:t>V705</a:t>
                </a:r>
                <a:endParaRPr lang="es-ES_tradnl" sz="1000" dirty="0"/>
              </a:p>
            </p:txBody>
          </p:sp>
          <p:sp>
            <p:nvSpPr>
              <p:cNvPr id="18" name="CuadroTexto 17"/>
              <p:cNvSpPr txBox="1"/>
              <p:nvPr/>
            </p:nvSpPr>
            <p:spPr>
              <a:xfrm rot="16200000">
                <a:off x="4503647" y="3650078"/>
                <a:ext cx="417481" cy="1778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dirty="0" smtClean="0"/>
                  <a:t>V739</a:t>
                </a:r>
                <a:endParaRPr lang="es-ES_tradnl" sz="1000" dirty="0"/>
              </a:p>
            </p:txBody>
          </p:sp>
          <p:sp>
            <p:nvSpPr>
              <p:cNvPr id="19" name="CuadroTexto 18"/>
              <p:cNvSpPr txBox="1"/>
              <p:nvPr/>
            </p:nvSpPr>
            <p:spPr>
              <a:xfrm rot="16200000">
                <a:off x="4689012" y="3650077"/>
                <a:ext cx="417481" cy="1778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dirty="0" smtClean="0"/>
                  <a:t>V740</a:t>
                </a:r>
                <a:endParaRPr lang="es-ES_tradnl" sz="1000" dirty="0"/>
              </a:p>
            </p:txBody>
          </p:sp>
          <p:sp>
            <p:nvSpPr>
              <p:cNvPr id="22" name="CuadroTexto 21"/>
              <p:cNvSpPr txBox="1"/>
              <p:nvPr/>
            </p:nvSpPr>
            <p:spPr>
              <a:xfrm rot="16200000">
                <a:off x="3963768" y="3535462"/>
                <a:ext cx="679881" cy="1778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smtClean="0"/>
                  <a:t>BW208-wt</a:t>
                </a:r>
                <a:endParaRPr lang="es-ES_tradnl" sz="1000" dirty="0"/>
              </a:p>
            </p:txBody>
          </p:sp>
        </p:grpSp>
        <p:grpSp>
          <p:nvGrpSpPr>
            <p:cNvPr id="25" name="Agrupar 24"/>
            <p:cNvGrpSpPr/>
            <p:nvPr/>
          </p:nvGrpSpPr>
          <p:grpSpPr>
            <a:xfrm>
              <a:off x="4706760" y="4076339"/>
              <a:ext cx="271647" cy="1978860"/>
              <a:chOff x="4596519" y="934995"/>
              <a:chExt cx="271647" cy="1978860"/>
            </a:xfrm>
          </p:grpSpPr>
          <p:sp>
            <p:nvSpPr>
              <p:cNvPr id="27" name="CuadroTexto 26"/>
              <p:cNvSpPr txBox="1"/>
              <p:nvPr/>
            </p:nvSpPr>
            <p:spPr>
              <a:xfrm>
                <a:off x="4596519" y="1196370"/>
                <a:ext cx="232280" cy="2264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dirty="0"/>
                  <a:t>𝞈</a:t>
                </a:r>
              </a:p>
            </p:txBody>
          </p:sp>
          <p:sp>
            <p:nvSpPr>
              <p:cNvPr id="28" name="Rectángulo 27"/>
              <p:cNvSpPr/>
              <p:nvPr/>
            </p:nvSpPr>
            <p:spPr>
              <a:xfrm>
                <a:off x="4611191" y="1749373"/>
                <a:ext cx="202468" cy="22643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_tradnl" sz="1000"/>
                  <a:t>𝝲</a:t>
                </a:r>
                <a:endParaRPr lang="es-ES_tradnl" sz="1000" dirty="0"/>
              </a:p>
            </p:txBody>
          </p:sp>
          <p:sp>
            <p:nvSpPr>
              <p:cNvPr id="29" name="CuadroTexto 28"/>
              <p:cNvSpPr txBox="1"/>
              <p:nvPr/>
            </p:nvSpPr>
            <p:spPr>
              <a:xfrm>
                <a:off x="4608325" y="2349091"/>
                <a:ext cx="214133" cy="2264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smtClean="0"/>
                  <a:t>𝝰</a:t>
                </a:r>
                <a:endParaRPr lang="es-ES_tradnl" sz="1000" dirty="0"/>
              </a:p>
            </p:txBody>
          </p:sp>
          <p:sp>
            <p:nvSpPr>
              <p:cNvPr id="30" name="Abrir llave 29"/>
              <p:cNvSpPr/>
              <p:nvPr/>
            </p:nvSpPr>
            <p:spPr>
              <a:xfrm>
                <a:off x="4808564" y="934995"/>
                <a:ext cx="54000" cy="756000"/>
              </a:xfrm>
              <a:prstGeom prst="leftBrac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 sz="1013"/>
              </a:p>
            </p:txBody>
          </p:sp>
          <p:sp>
            <p:nvSpPr>
              <p:cNvPr id="31" name="Abrir llave 30"/>
              <p:cNvSpPr/>
              <p:nvPr/>
            </p:nvSpPr>
            <p:spPr>
              <a:xfrm>
                <a:off x="4812337" y="1685063"/>
                <a:ext cx="55466" cy="360000"/>
              </a:xfrm>
              <a:prstGeom prst="leftBrac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 sz="1013"/>
              </a:p>
            </p:txBody>
          </p:sp>
          <p:sp>
            <p:nvSpPr>
              <p:cNvPr id="32" name="Abrir llave 31"/>
              <p:cNvSpPr/>
              <p:nvPr/>
            </p:nvSpPr>
            <p:spPr>
              <a:xfrm>
                <a:off x="4812951" y="2049855"/>
                <a:ext cx="55215" cy="864000"/>
              </a:xfrm>
              <a:prstGeom prst="leftBrac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 sz="1013"/>
              </a:p>
            </p:txBody>
          </p:sp>
        </p:grpSp>
      </p:grpSp>
      <p:sp>
        <p:nvSpPr>
          <p:cNvPr id="40" name="CuadroTexto 39"/>
          <p:cNvSpPr txBox="1"/>
          <p:nvPr/>
        </p:nvSpPr>
        <p:spPr>
          <a:xfrm>
            <a:off x="219075" y="9563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a</a:t>
            </a:r>
            <a:endParaRPr lang="es-ES_tradnl"/>
          </a:p>
        </p:txBody>
      </p:sp>
      <p:sp>
        <p:nvSpPr>
          <p:cNvPr id="41" name="CuadroTexto 40"/>
          <p:cNvSpPr txBox="1"/>
          <p:nvPr/>
        </p:nvSpPr>
        <p:spPr>
          <a:xfrm>
            <a:off x="3101128" y="113909"/>
            <a:ext cx="401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mtClean="0"/>
              <a:t>b</a:t>
            </a:r>
            <a:endParaRPr lang="es-ES_tradnl"/>
          </a:p>
        </p:txBody>
      </p:sp>
      <p:sp>
        <p:nvSpPr>
          <p:cNvPr id="33" name="CuadroTexto 32"/>
          <p:cNvSpPr txBox="1"/>
          <p:nvPr/>
        </p:nvSpPr>
        <p:spPr>
          <a:xfrm>
            <a:off x="418905" y="248176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/>
              <a:t>c</a:t>
            </a:r>
            <a:endParaRPr lang="es-ES_tradnl" dirty="0"/>
          </a:p>
        </p:txBody>
      </p:sp>
      <p:sp>
        <p:nvSpPr>
          <p:cNvPr id="34" name="CuadroTexto 33"/>
          <p:cNvSpPr txBox="1"/>
          <p:nvPr/>
        </p:nvSpPr>
        <p:spPr>
          <a:xfrm>
            <a:off x="3891010" y="250098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d</a:t>
            </a:r>
            <a:endParaRPr lang="es-ES_tradnl"/>
          </a:p>
        </p:txBody>
      </p:sp>
      <p:graphicFrame>
        <p:nvGraphicFramePr>
          <p:cNvPr id="24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8209246"/>
              </p:ext>
            </p:extLst>
          </p:nvPr>
        </p:nvGraphicFramePr>
        <p:xfrm>
          <a:off x="418905" y="279002"/>
          <a:ext cx="3330081" cy="22027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3947058"/>
              </p:ext>
            </p:extLst>
          </p:nvPr>
        </p:nvGraphicFramePr>
        <p:xfrm>
          <a:off x="3395132" y="113909"/>
          <a:ext cx="3183467" cy="2195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7" name="3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6684458"/>
              </p:ext>
            </p:extLst>
          </p:nvPr>
        </p:nvGraphicFramePr>
        <p:xfrm>
          <a:off x="313164" y="3288887"/>
          <a:ext cx="3731093" cy="2092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8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2029992"/>
              </p:ext>
            </p:extLst>
          </p:nvPr>
        </p:nvGraphicFramePr>
        <p:xfrm>
          <a:off x="313164" y="6102227"/>
          <a:ext cx="3246795" cy="2476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9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5938163"/>
              </p:ext>
            </p:extLst>
          </p:nvPr>
        </p:nvGraphicFramePr>
        <p:xfrm>
          <a:off x="3302000" y="6126486"/>
          <a:ext cx="3437467" cy="24304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2" name="CuadroTexto 41"/>
          <p:cNvSpPr txBox="1"/>
          <p:nvPr/>
        </p:nvSpPr>
        <p:spPr>
          <a:xfrm>
            <a:off x="419024" y="552859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e</a:t>
            </a:r>
          </a:p>
        </p:txBody>
      </p:sp>
      <p:sp>
        <p:nvSpPr>
          <p:cNvPr id="43" name="CuadroTexto 42"/>
          <p:cNvSpPr txBox="1"/>
          <p:nvPr/>
        </p:nvSpPr>
        <p:spPr>
          <a:xfrm>
            <a:off x="3891010" y="548714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/>
              <a:t>f</a:t>
            </a:r>
            <a:endParaRPr lang="es-ES_tradnl" dirty="0"/>
          </a:p>
        </p:txBody>
      </p:sp>
      <p:sp>
        <p:nvSpPr>
          <p:cNvPr id="44" name="CuadroTexto 43"/>
          <p:cNvSpPr txBox="1"/>
          <p:nvPr/>
        </p:nvSpPr>
        <p:spPr>
          <a:xfrm>
            <a:off x="926069" y="5110135"/>
            <a:ext cx="224893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_tradnl" sz="1000" dirty="0" smtClean="0"/>
              <a:t>        </a:t>
            </a:r>
            <a:r>
              <a:rPr lang="es-ES_tradnl" sz="1000" dirty="0" err="1" smtClean="0"/>
              <a:t>ω</a:t>
            </a:r>
            <a:r>
              <a:rPr lang="es-ES_tradnl" sz="1000" dirty="0" smtClean="0"/>
              <a:t>                        α                        </a:t>
            </a:r>
            <a:r>
              <a:rPr lang="es-ES_tradnl" sz="1000" dirty="0" err="1" smtClean="0"/>
              <a:t>ɣ</a:t>
            </a:r>
            <a:r>
              <a:rPr lang="es-ES_tradnl" sz="1000" dirty="0" smtClean="0"/>
              <a:t> </a:t>
            </a:r>
          </a:p>
          <a:p>
            <a:pPr algn="ctr"/>
            <a:r>
              <a:rPr lang="es-ES_tradnl" sz="1000" dirty="0" err="1" smtClean="0"/>
              <a:t>Gliadin</a:t>
            </a:r>
            <a:r>
              <a:rPr lang="es-ES_tradnl" sz="1000" dirty="0" smtClean="0"/>
              <a:t> </a:t>
            </a:r>
            <a:r>
              <a:rPr lang="es-ES_tradnl" sz="1000" dirty="0" err="1" smtClean="0"/>
              <a:t>fraction</a:t>
            </a:r>
            <a:endParaRPr lang="es-ES_tradnl" sz="1000" dirty="0"/>
          </a:p>
        </p:txBody>
      </p:sp>
      <p:sp>
        <p:nvSpPr>
          <p:cNvPr id="2" name="Rectángulo 1"/>
          <p:cNvSpPr/>
          <p:nvPr/>
        </p:nvSpPr>
        <p:spPr>
          <a:xfrm>
            <a:off x="0" y="9536668"/>
            <a:ext cx="20845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15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42727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9</TotalTime>
  <Words>52</Words>
  <Application>Microsoft Macintosh PowerPoint</Application>
  <PresentationFormat>A4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isco Barro</dc:creator>
  <cp:lastModifiedBy>Francisco Barro</cp:lastModifiedBy>
  <cp:revision>124</cp:revision>
  <dcterms:created xsi:type="dcterms:W3CDTF">2016-03-10T08:01:05Z</dcterms:created>
  <dcterms:modified xsi:type="dcterms:W3CDTF">2017-08-01T08:31:19Z</dcterms:modified>
</cp:coreProperties>
</file>